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97" autoAdjust="0"/>
    <p:restoredTop sz="96405"/>
  </p:normalViewPr>
  <p:slideViewPr>
    <p:cSldViewPr snapToGrid="0">
      <p:cViewPr varScale="1">
        <p:scale>
          <a:sx n="154" d="100"/>
          <a:sy n="154" d="100"/>
        </p:scale>
        <p:origin x="2608" y="20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7648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74047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47260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7891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69776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08070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64622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75089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05097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40059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90583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84F02B-BCC2-B34D-A842-589DD282421A}" type="datetimeFigureOut">
              <a:rPr lang="fr-FR" smtClean="0"/>
              <a:pPr/>
              <a:t>14/11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DBF153-BDF8-014B-8143-B165DE9BB631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70570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ZoneTexte 149">
            <a:extLst>
              <a:ext uri="{FF2B5EF4-FFF2-40B4-BE49-F238E27FC236}">
                <a16:creationId xmlns:a16="http://schemas.microsoft.com/office/drawing/2014/main" id="{F540D0ED-8C63-DBB5-6638-1E4495D5B51F}"/>
              </a:ext>
            </a:extLst>
          </p:cNvPr>
          <p:cNvSpPr txBox="1"/>
          <p:nvPr/>
        </p:nvSpPr>
        <p:spPr>
          <a:xfrm>
            <a:off x="120582" y="8120896"/>
            <a:ext cx="6616835" cy="161582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verification of </a:t>
            </a:r>
            <a:r>
              <a:rPr lang="en-US" sz="1100" b="1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n-US" sz="11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</a:t>
            </a:r>
            <a:r>
              <a:rPr lang="en-U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-crtE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the </a:t>
            </a:r>
            <a:r>
              <a:rPr lang="en-U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LS-crtE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smids in </a:t>
            </a:r>
            <a:r>
              <a:rPr lang="en-US" sz="1100" b="1" i="1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nechocystis</a:t>
            </a:r>
            <a:r>
              <a:rPr lang="en-US" sz="11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C 6803 </a:t>
            </a:r>
            <a:r>
              <a:rPr lang="en-US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chematic representation of the </a:t>
            </a:r>
            <a:r>
              <a:rPr lang="en-US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F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-crtE6803 and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F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-crtE7002 plasmids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ing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ong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moter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iangle)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</a:t>
            </a:r>
            <a:r>
              <a:rPr lang="fr-FR" sz="11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thetic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peron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coding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11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rnesene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nthase (FS) and </a:t>
            </a:r>
            <a:r>
              <a:rPr lang="fr-FR" sz="11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ither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tE6803 or crtE7002 </a:t>
            </a:r>
            <a:r>
              <a:rPr lang="fr-FR" sz="11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ins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BS (</a:t>
            </a:r>
            <a:r>
              <a:rPr lang="fr-FR" sz="11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all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leu rectangle) stands for ribosome binding site. </a:t>
            </a:r>
            <a:r>
              <a:rPr lang="fr-FR" sz="11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fr-FR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</a:t>
            </a:r>
            <a:r>
              <a:rPr lang="fr-FR" sz="110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fr-FR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relevant parts of </a:t>
            </a:r>
            <a:r>
              <a:rPr lang="en-US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F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-crtE6803 and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F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-crtE7002 </a:t>
            </a:r>
            <a:r>
              <a:rPr lang="fr-FR" sz="110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lified</a:t>
            </a:r>
            <a:r>
              <a:rPr lang="fr-FR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propriate</a:t>
            </a:r>
            <a:r>
              <a:rPr lang="fr-FR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imers</a:t>
            </a:r>
            <a:r>
              <a:rPr lang="fr-FR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fr-FR" sz="11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) </a:t>
            </a:r>
            <a:r>
              <a:rPr lang="en-US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representation of </a:t>
            </a:r>
            <a:r>
              <a:rPr lang="en-US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-crtE6803 and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-crtE7002 </a:t>
            </a:r>
            <a:r>
              <a:rPr lang="fr-FR" sz="11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coding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11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monene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nthase (LS) </a:t>
            </a:r>
            <a:r>
              <a:rPr lang="fr-FR" sz="11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ither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tE6803 or CrtE7002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1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fr-FR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</a:t>
            </a:r>
            <a:r>
              <a:rPr lang="fr-FR" sz="110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fr-FR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relevant part of </a:t>
            </a:r>
            <a:r>
              <a:rPr lang="en-US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-crtE6803 and</a:t>
            </a:r>
            <a:r>
              <a:rPr lang="fr-FR" sz="11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-crtE7002. </a:t>
            </a:r>
            <a:r>
              <a:rPr lang="en-US" sz="11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ze marker M1</a:t>
            </a:r>
            <a:r>
              <a:rPr lang="en-US" sz="1100" b="0" i="0" u="none" strike="noStrike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orresponds to the </a:t>
            </a:r>
            <a:r>
              <a:rPr lang="fr-FR" sz="11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uick-</a:t>
            </a:r>
            <a:r>
              <a:rPr lang="fr-FR" sz="1100" b="0" i="0" u="none" strike="noStrike" baseline="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oad</a:t>
            </a:r>
            <a:r>
              <a:rPr lang="fr-FR" sz="11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1kb Plus DNA Ladder (NEB). </a:t>
            </a:r>
            <a:r>
              <a:rPr lang="fr-FR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2 correspond to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1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eruler</a:t>
            </a:r>
            <a:r>
              <a:rPr lang="fr-FR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1 kb Plus DNA Ladder (</a:t>
            </a:r>
            <a:r>
              <a:rPr lang="fr-FR" sz="1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rmofisher</a:t>
            </a:r>
            <a:r>
              <a:rPr lang="fr-FR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fr-FR" sz="11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Gel images</a:t>
            </a:r>
            <a:r>
              <a:rPr lang="fr-FR" sz="1100" b="0" i="0" u="none" strike="noStrike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esented in </a:t>
            </a:r>
            <a:r>
              <a:rPr lang="en-US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lack or pink were captured with different apparatus.</a:t>
            </a:r>
            <a:endParaRPr lang="fr-FR" sz="11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54767F4B-E8F6-7410-2EBF-BB1159AC2B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110169"/>
            <a:ext cx="6858000" cy="78069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79569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69</TotalTime>
  <Words>159</Words>
  <Application>Microsoft Macintosh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ine Vincent</dc:creator>
  <cp:lastModifiedBy>Franck Chauvat</cp:lastModifiedBy>
  <cp:revision>46</cp:revision>
  <dcterms:created xsi:type="dcterms:W3CDTF">2023-10-08T21:06:11Z</dcterms:created>
  <dcterms:modified xsi:type="dcterms:W3CDTF">2023-11-14T14:33:51Z</dcterms:modified>
</cp:coreProperties>
</file>